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>
      <p:cViewPr varScale="1">
        <p:scale>
          <a:sx n="121" d="100"/>
          <a:sy n="121" d="100"/>
        </p:scale>
        <p:origin x="1904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6/3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E:\新建文件夹\HIIT LC 苏\figures\primary\Cardiovascular complication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7" y="5040352"/>
            <a:ext cx="7419975" cy="15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E:\新建文件夹\HIIT LC 苏\figures\primary\Respiratory failure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5" y="3508040"/>
            <a:ext cx="7419975" cy="15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E:\新建文件夹\HIIT LC 苏\figures\primary\30-day mortality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7" y="1819680"/>
            <a:ext cx="7419975" cy="1676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E:\新建文件夹\HIIT LC 苏\figures\primary\Arhythmia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0"/>
            <a:ext cx="7419975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168397" y="-9144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177391" y="1732290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77391" y="3384376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177637" y="4933488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D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D3E62CF-AF46-E119-E438-188C6AAD66C8}"/>
              </a:ext>
            </a:extLst>
          </p:cNvPr>
          <p:cNvSpPr txBox="1"/>
          <p:nvPr/>
        </p:nvSpPr>
        <p:spPr>
          <a:xfrm>
            <a:off x="829158" y="6457488"/>
            <a:ext cx="79928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Effect of high-intensity interval training on the risk of arrhythmia (A), 30-day mortality (B), respiratory failure (C) and cardiovascular complication (D) among surgical lung cancer patients.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1832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3</Words>
  <Application>Microsoft Macintosh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华西医院</dc:creator>
  <cp:lastModifiedBy>A7522</cp:lastModifiedBy>
  <cp:revision>3</cp:revision>
  <dcterms:created xsi:type="dcterms:W3CDTF">2025-11-05T07:34:20Z</dcterms:created>
  <dcterms:modified xsi:type="dcterms:W3CDTF">2026-03-13T03:32:57Z</dcterms:modified>
</cp:coreProperties>
</file>